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596" autoAdjust="0"/>
    <p:restoredTop sz="94675" autoAdjust="0"/>
  </p:normalViewPr>
  <p:slideViewPr>
    <p:cSldViewPr>
      <p:cViewPr>
        <p:scale>
          <a:sx n="75" d="100"/>
          <a:sy n="75" d="100"/>
        </p:scale>
        <p:origin x="-1108" y="52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92C95F-D648-43DD-B0B8-6DD78E51B8CF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0BDE49-A2B7-4CA6-A44C-51E4401C339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2CA03A-9829-4841-A713-B4364DF3346D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F0D3B1-89F9-4F9F-ABAE-947C0BBC159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186E72-EE79-4EDB-8474-ABA45B1E015D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07520F-6B51-42A0-8C7F-0ED2CDC42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908289-1081-491C-A17B-772DF268CBB9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7CE-5A6E-4D87-AB19-81D79391DA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9873FB-3CDC-4436-AB70-CFEC9A40A7FD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266860-F483-42C8-8408-7086F1C0050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39405D-D992-46AE-88C6-B87E7350324E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C6804A-3C59-45E9-AE98-A6F19072346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BFB088-4400-4F71-BBF6-06DC921F1391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5F7930-3607-43AB-8A23-63CFF064409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8610F0-5C58-4D23-B1B0-3F778FBE1166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E89AE7-94E6-4794-9DDE-FFADFF6F9E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2FE75A-87EE-4CE6-989F-4D00F71210F9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7C6718-E5C6-44E9-95C7-5725B499C6C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C00A5B-8EB2-4F42-A37F-E51C7B5D68AD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4D0CD7-3E96-4965-AB8B-8A9EFE457D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0E9E28-4AA4-40CD-BDBD-2F02B1FFA9BE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6D8AC3-39B1-4122-A0A9-8A3409438FB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184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1"/>
            <a:ext cx="6172200" cy="60346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3CA3BAA-A082-49CC-9640-D1463F8C7791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B56BFE0-61C9-4289-8364-091E3422B27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5187769"/>
              </p:ext>
            </p:extLst>
          </p:nvPr>
        </p:nvGraphicFramePr>
        <p:xfrm>
          <a:off x="1955426" y="1053944"/>
          <a:ext cx="2497643" cy="2005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4" name="Image" r:id="rId3" imgW="5091840" imgH="4088880" progId="Photoshop.Image.7">
                  <p:embed/>
                </p:oleObj>
              </mc:Choice>
              <mc:Fallback>
                <p:oleObj name="Image" r:id="rId3" imgW="5091840" imgH="4088880" progId="Photoshop.Image.7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55426" y="1053944"/>
                        <a:ext cx="2497643" cy="20058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Box 6"/>
          <p:cNvSpPr txBox="1">
            <a:spLocks noChangeArrowheads="1"/>
          </p:cNvSpPr>
          <p:nvPr/>
        </p:nvSpPr>
        <p:spPr bwMode="auto">
          <a:xfrm>
            <a:off x="1202434" y="3146132"/>
            <a:ext cx="93326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MAP1723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7"/>
          <p:cNvSpPr txBox="1">
            <a:spLocks noChangeArrowheads="1"/>
          </p:cNvSpPr>
          <p:nvPr/>
        </p:nvSpPr>
        <p:spPr bwMode="auto">
          <a:xfrm>
            <a:off x="3761761" y="3142748"/>
            <a:ext cx="218200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MAP2705seq2/MAP2733R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8"/>
          <p:cNvSpPr txBox="1">
            <a:spLocks noChangeArrowheads="1"/>
          </p:cNvSpPr>
          <p:nvPr/>
        </p:nvSpPr>
        <p:spPr bwMode="auto">
          <a:xfrm>
            <a:off x="2627674" y="663336"/>
            <a:ext cx="101341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MAP3733c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9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4724948"/>
              </p:ext>
            </p:extLst>
          </p:nvPr>
        </p:nvGraphicFramePr>
        <p:xfrm>
          <a:off x="3528279" y="3419872"/>
          <a:ext cx="2547937" cy="1922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5" name="Image" r:id="rId5" imgW="5383800" imgH="4063320" progId="Photoshop.Image.7">
                  <p:embed/>
                </p:oleObj>
              </mc:Choice>
              <mc:Fallback>
                <p:oleObj name="Image" r:id="rId5" imgW="5383800" imgH="4063320" progId="Photoshop.Image.7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28279" y="3419872"/>
                        <a:ext cx="2547937" cy="19224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5327013"/>
              </p:ext>
            </p:extLst>
          </p:nvPr>
        </p:nvGraphicFramePr>
        <p:xfrm>
          <a:off x="484388" y="3428800"/>
          <a:ext cx="2356991" cy="19442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66" name="Image" r:id="rId7" imgW="3733200" imgH="4050720" progId="Photoshop.Image.7">
                  <p:embed/>
                </p:oleObj>
              </mc:Choice>
              <mc:Fallback>
                <p:oleObj name="Image" r:id="rId7" imgW="3733200" imgH="4050720" progId="Photoshop.Image.7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4388" y="3428800"/>
                        <a:ext cx="2356991" cy="194421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22"/>
          <p:cNvSpPr txBox="1">
            <a:spLocks noChangeArrowheads="1"/>
          </p:cNvSpPr>
          <p:nvPr/>
        </p:nvSpPr>
        <p:spPr bwMode="auto">
          <a:xfrm>
            <a:off x="726598" y="3434392"/>
            <a:ext cx="76014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316FUK200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22"/>
          <p:cNvSpPr txBox="1">
            <a:spLocks noChangeArrowheads="1"/>
          </p:cNvSpPr>
          <p:nvPr/>
        </p:nvSpPr>
        <p:spPr bwMode="auto">
          <a:xfrm>
            <a:off x="1373033" y="3434392"/>
            <a:ext cx="63991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2eUK200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22"/>
          <p:cNvSpPr txBox="1">
            <a:spLocks noChangeArrowheads="1"/>
          </p:cNvSpPr>
          <p:nvPr/>
        </p:nvSpPr>
        <p:spPr bwMode="auto">
          <a:xfrm>
            <a:off x="1977095" y="3429164"/>
            <a:ext cx="62388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IIUK200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22"/>
          <p:cNvSpPr txBox="1">
            <a:spLocks noChangeArrowheads="1"/>
          </p:cNvSpPr>
          <p:nvPr/>
        </p:nvSpPr>
        <p:spPr bwMode="auto">
          <a:xfrm>
            <a:off x="821786" y="3574796"/>
            <a:ext cx="2535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22"/>
          <p:cNvSpPr txBox="1">
            <a:spLocks noChangeArrowheads="1"/>
          </p:cNvSpPr>
          <p:nvPr/>
        </p:nvSpPr>
        <p:spPr bwMode="auto">
          <a:xfrm>
            <a:off x="1086667" y="3574796"/>
            <a:ext cx="2648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22"/>
          <p:cNvSpPr txBox="1">
            <a:spLocks noChangeArrowheads="1"/>
          </p:cNvSpPr>
          <p:nvPr/>
        </p:nvSpPr>
        <p:spPr bwMode="auto">
          <a:xfrm>
            <a:off x="1455412" y="3574796"/>
            <a:ext cx="2535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22"/>
          <p:cNvSpPr txBox="1">
            <a:spLocks noChangeArrowheads="1"/>
          </p:cNvSpPr>
          <p:nvPr/>
        </p:nvSpPr>
        <p:spPr bwMode="auto">
          <a:xfrm>
            <a:off x="1720293" y="3574796"/>
            <a:ext cx="2648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22"/>
          <p:cNvSpPr txBox="1">
            <a:spLocks noChangeArrowheads="1"/>
          </p:cNvSpPr>
          <p:nvPr/>
        </p:nvSpPr>
        <p:spPr bwMode="auto">
          <a:xfrm>
            <a:off x="2015342" y="3574796"/>
            <a:ext cx="2535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22"/>
          <p:cNvSpPr txBox="1">
            <a:spLocks noChangeArrowheads="1"/>
          </p:cNvSpPr>
          <p:nvPr/>
        </p:nvSpPr>
        <p:spPr bwMode="auto">
          <a:xfrm>
            <a:off x="2280223" y="3574796"/>
            <a:ext cx="2648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22"/>
          <p:cNvSpPr txBox="1">
            <a:spLocks noChangeArrowheads="1"/>
          </p:cNvSpPr>
          <p:nvPr/>
        </p:nvSpPr>
        <p:spPr bwMode="auto">
          <a:xfrm>
            <a:off x="3771394" y="3436008"/>
            <a:ext cx="76014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316FUK200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22"/>
          <p:cNvSpPr txBox="1">
            <a:spLocks noChangeArrowheads="1"/>
          </p:cNvSpPr>
          <p:nvPr/>
        </p:nvSpPr>
        <p:spPr bwMode="auto">
          <a:xfrm>
            <a:off x="4417829" y="3436008"/>
            <a:ext cx="63991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2eUK200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22"/>
          <p:cNvSpPr txBox="1">
            <a:spLocks noChangeArrowheads="1"/>
          </p:cNvSpPr>
          <p:nvPr/>
        </p:nvSpPr>
        <p:spPr bwMode="auto">
          <a:xfrm>
            <a:off x="5021891" y="3430780"/>
            <a:ext cx="62388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IIUK200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22"/>
          <p:cNvSpPr txBox="1">
            <a:spLocks noChangeArrowheads="1"/>
          </p:cNvSpPr>
          <p:nvPr/>
        </p:nvSpPr>
        <p:spPr bwMode="auto">
          <a:xfrm>
            <a:off x="3866582" y="3576412"/>
            <a:ext cx="2535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22"/>
          <p:cNvSpPr txBox="1">
            <a:spLocks noChangeArrowheads="1"/>
          </p:cNvSpPr>
          <p:nvPr/>
        </p:nvSpPr>
        <p:spPr bwMode="auto">
          <a:xfrm>
            <a:off x="4131463" y="3576412"/>
            <a:ext cx="2648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22"/>
          <p:cNvSpPr txBox="1">
            <a:spLocks noChangeArrowheads="1"/>
          </p:cNvSpPr>
          <p:nvPr/>
        </p:nvSpPr>
        <p:spPr bwMode="auto">
          <a:xfrm>
            <a:off x="4500208" y="3576412"/>
            <a:ext cx="2535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22"/>
          <p:cNvSpPr txBox="1">
            <a:spLocks noChangeArrowheads="1"/>
          </p:cNvSpPr>
          <p:nvPr/>
        </p:nvSpPr>
        <p:spPr bwMode="auto">
          <a:xfrm>
            <a:off x="4765089" y="3576412"/>
            <a:ext cx="2648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22"/>
          <p:cNvSpPr txBox="1">
            <a:spLocks noChangeArrowheads="1"/>
          </p:cNvSpPr>
          <p:nvPr/>
        </p:nvSpPr>
        <p:spPr bwMode="auto">
          <a:xfrm>
            <a:off x="5060138" y="3576412"/>
            <a:ext cx="2535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22"/>
          <p:cNvSpPr txBox="1">
            <a:spLocks noChangeArrowheads="1"/>
          </p:cNvSpPr>
          <p:nvPr/>
        </p:nvSpPr>
        <p:spPr bwMode="auto">
          <a:xfrm>
            <a:off x="5325019" y="3576412"/>
            <a:ext cx="2648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22"/>
          <p:cNvSpPr txBox="1">
            <a:spLocks noChangeArrowheads="1"/>
          </p:cNvSpPr>
          <p:nvPr/>
        </p:nvSpPr>
        <p:spPr bwMode="auto">
          <a:xfrm>
            <a:off x="2225551" y="1188144"/>
            <a:ext cx="76014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316FUK200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22"/>
          <p:cNvSpPr txBox="1">
            <a:spLocks noChangeArrowheads="1"/>
          </p:cNvSpPr>
          <p:nvPr/>
        </p:nvSpPr>
        <p:spPr bwMode="auto">
          <a:xfrm>
            <a:off x="2871986" y="1188144"/>
            <a:ext cx="63991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2eUK200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22"/>
          <p:cNvSpPr txBox="1">
            <a:spLocks noChangeArrowheads="1"/>
          </p:cNvSpPr>
          <p:nvPr/>
        </p:nvSpPr>
        <p:spPr bwMode="auto">
          <a:xfrm>
            <a:off x="3476048" y="1182916"/>
            <a:ext cx="62388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IIUK2001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22"/>
          <p:cNvSpPr txBox="1">
            <a:spLocks noChangeArrowheads="1"/>
          </p:cNvSpPr>
          <p:nvPr/>
        </p:nvSpPr>
        <p:spPr bwMode="auto">
          <a:xfrm>
            <a:off x="2585620" y="1328548"/>
            <a:ext cx="2648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22"/>
          <p:cNvSpPr txBox="1">
            <a:spLocks noChangeArrowheads="1"/>
          </p:cNvSpPr>
          <p:nvPr/>
        </p:nvSpPr>
        <p:spPr bwMode="auto">
          <a:xfrm>
            <a:off x="2954365" y="1328548"/>
            <a:ext cx="2535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22"/>
          <p:cNvSpPr txBox="1">
            <a:spLocks noChangeArrowheads="1"/>
          </p:cNvSpPr>
          <p:nvPr/>
        </p:nvSpPr>
        <p:spPr bwMode="auto">
          <a:xfrm>
            <a:off x="3219246" y="1328548"/>
            <a:ext cx="2648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22"/>
          <p:cNvSpPr txBox="1">
            <a:spLocks noChangeArrowheads="1"/>
          </p:cNvSpPr>
          <p:nvPr/>
        </p:nvSpPr>
        <p:spPr bwMode="auto">
          <a:xfrm>
            <a:off x="3514295" y="1328548"/>
            <a:ext cx="2535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22"/>
          <p:cNvSpPr txBox="1">
            <a:spLocks noChangeArrowheads="1"/>
          </p:cNvSpPr>
          <p:nvPr/>
        </p:nvSpPr>
        <p:spPr bwMode="auto">
          <a:xfrm>
            <a:off x="3779176" y="1328548"/>
            <a:ext cx="26481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800" b="1" dirty="0" smtClean="0">
                <a:latin typeface="Times New Roman" pitchFamily="18" charset="0"/>
                <a:cs typeface="Times New Roman" pitchFamily="18" charset="0"/>
              </a:rPr>
              <a:t>H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 flipH="1">
            <a:off x="503949" y="96475"/>
            <a:ext cx="54005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Times New Roman" pitchFamily="18" charset="0"/>
                <a:cs typeface="Times New Roman" pitchFamily="18" charset="0"/>
              </a:rPr>
              <a:t>Additional File 1: </a:t>
            </a:r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PCR amplification for vGI-19, vGI-20 and vGI</a:t>
            </a:r>
            <a:r>
              <a:rPr lang="en-GB" sz="1400" b="1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GB" sz="1400" b="1" dirty="0" smtClean="0">
                <a:latin typeface="Times New Roman" pitchFamily="18" charset="0"/>
                <a:cs typeface="Times New Roman" pitchFamily="18" charset="0"/>
              </a:rPr>
              <a:t>21 in 316FUK2001, 2eUK2001 and IIUK2001 strains </a:t>
            </a:r>
          </a:p>
        </p:txBody>
      </p:sp>
      <p:sp>
        <p:nvSpPr>
          <p:cNvPr id="64" name="TextBox 63"/>
          <p:cNvSpPr txBox="1"/>
          <p:nvPr/>
        </p:nvSpPr>
        <p:spPr>
          <a:xfrm flipH="1">
            <a:off x="149775" y="5508104"/>
            <a:ext cx="649579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1.5%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garose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gels showing gene specific PCR 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amplicons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generated using specific gene primer sets for </a:t>
            </a:r>
          </a:p>
          <a:p>
            <a:pPr algn="just"/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1)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resence of a gene within the vGI-19 region [MAP3733c.F,MAP3733c.R] </a:t>
            </a:r>
          </a:p>
          <a:p>
            <a:pPr algn="just"/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2) Presence of a gene within the vGI-20 region [MAP1723.F, MAP1723.R]</a:t>
            </a:r>
          </a:p>
          <a:p>
            <a:pPr algn="just"/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3)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Presence of a duplication of the vGI-21 region [MAP2705.SEQ2, MAP2733.R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]</a:t>
            </a:r>
          </a:p>
          <a:p>
            <a:pPr algn="just"/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tandard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PCR conditions (see methods)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were used with 56°C annealing and high (H) and low (L) concentrations of genomic DNA preparations from MAP strains 316FUK2001. 2eUK2001 and IIUK2001. </a:t>
            </a:r>
          </a:p>
          <a:p>
            <a:pPr algn="just"/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Results confirm the presence of vGI-19 region in all strains, the presence of a duplication of vGI-21 in IIUK2001 and absence of vGI-20 in strains 2eUK2001 and IIUK2001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387285" y="817224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)</a:t>
            </a:r>
            <a:endParaRPr lang="en-GB" dirty="0"/>
          </a:p>
        </p:txBody>
      </p:sp>
      <p:sp>
        <p:nvSpPr>
          <p:cNvPr id="63" name="TextBox 62"/>
          <p:cNvSpPr txBox="1"/>
          <p:nvPr/>
        </p:nvSpPr>
        <p:spPr>
          <a:xfrm>
            <a:off x="114099" y="3207080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2</a:t>
            </a:r>
            <a:r>
              <a:rPr lang="en-GB" dirty="0" smtClean="0"/>
              <a:t>)</a:t>
            </a:r>
            <a:endParaRPr lang="en-GB" dirty="0"/>
          </a:p>
        </p:txBody>
      </p:sp>
      <p:sp>
        <p:nvSpPr>
          <p:cNvPr id="65" name="TextBox 64"/>
          <p:cNvSpPr txBox="1"/>
          <p:nvPr/>
        </p:nvSpPr>
        <p:spPr>
          <a:xfrm>
            <a:off x="3081163" y="3175605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</a:t>
            </a:r>
            <a:r>
              <a:rPr lang="en-GB" dirty="0" smtClean="0"/>
              <a:t>)</a:t>
            </a:r>
            <a:endParaRPr lang="en-GB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179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Image</vt:lpstr>
      <vt:lpstr>PowerPoint Presentation</vt:lpstr>
    </vt:vector>
  </TitlesOfParts>
  <Company>Moredun Research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tevenson</dc:creator>
  <cp:lastModifiedBy>Licenced User</cp:lastModifiedBy>
  <cp:revision>16</cp:revision>
  <dcterms:created xsi:type="dcterms:W3CDTF">2010-09-16T08:56:35Z</dcterms:created>
  <dcterms:modified xsi:type="dcterms:W3CDTF">2012-12-03T16:55:41Z</dcterms:modified>
</cp:coreProperties>
</file>